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1.jpeg" ContentType="image/jpeg"/>
  <Override PartName="/ppt/media/image9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8DE81-54B0-4303-98FD-2B09172327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6CF16-F334-41B5-B229-359DCE787C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3EA3E-D3BF-4701-9919-059BFACF71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AE4A9-F8B9-42D3-8A5C-CF03F194E9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7CF1F-9254-42DE-930B-3104D40D86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38FE5-63BD-4EBE-8A72-1CC3AD4F04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2D19B-2CBF-4150-A8EB-795E053CB9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155A6-2AAC-45D1-9E2D-16347FDB91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74D2A9-69E8-443A-B1D7-F72159C993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311EF-6EDB-4C46-9F51-62038D465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3427E-998A-4513-948A-394D2A8D1F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D7ED8-04D6-4373-A6D7-1770B35363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7F3AB66-645A-4562-B3AF-B83E3076111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570240" y="1036800"/>
            <a:ext cx="194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NF168 nucleus high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4" descr="I:\phD\TMA\RNF168\images\8a e5\RNF168 high nucl modified.tif"/>
          <p:cNvPicPr/>
          <p:nvPr/>
        </p:nvPicPr>
        <p:blipFill>
          <a:blip r:embed="rId1"/>
          <a:srcRect l="4351" t="0" r="0" b="0"/>
          <a:stretch/>
        </p:blipFill>
        <p:spPr>
          <a:xfrm>
            <a:off x="733320" y="1407960"/>
            <a:ext cx="1619280" cy="162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5" descr="I:\phD\TMA\RNF168\images\8a e5\RNF168 high nucl_amp modified.tif"/>
          <p:cNvPicPr/>
          <p:nvPr/>
        </p:nvPicPr>
        <p:blipFill>
          <a:blip r:embed="rId2"/>
          <a:srcRect l="14274" t="3896" r="0" b="8838"/>
          <a:stretch/>
        </p:blipFill>
        <p:spPr>
          <a:xfrm>
            <a:off x="1452600" y="2128680"/>
            <a:ext cx="9000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TextBox 6"/>
          <p:cNvSpPr/>
          <p:nvPr/>
        </p:nvSpPr>
        <p:spPr>
          <a:xfrm>
            <a:off x="4618080" y="1036800"/>
            <a:ext cx="116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M1 low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oup 7"/>
          <p:cNvGrpSpPr/>
          <p:nvPr/>
        </p:nvGrpSpPr>
        <p:grpSpPr>
          <a:xfrm>
            <a:off x="4368960" y="1407960"/>
            <a:ext cx="1658880" cy="1621080"/>
            <a:chOff x="4368960" y="1407960"/>
            <a:chExt cx="1658880" cy="1621080"/>
          </a:xfrm>
        </p:grpSpPr>
        <p:pic>
          <p:nvPicPr>
            <p:cNvPr id="46" name="Picture 8" descr="I:\phD\TMA\RNF168\images\8a e5\FOXM1 low modified.tif"/>
            <p:cNvPicPr/>
            <p:nvPr/>
          </p:nvPicPr>
          <p:blipFill>
            <a:blip r:embed="rId3"/>
            <a:stretch/>
          </p:blipFill>
          <p:spPr>
            <a:xfrm>
              <a:off x="4368960" y="1407960"/>
              <a:ext cx="1658880" cy="1621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7" name="Picture 9" descr="I:\phD\TMA\RNF168\images\8a e5\FOXM1 low amp modified.tif"/>
            <p:cNvPicPr/>
            <p:nvPr/>
          </p:nvPicPr>
          <p:blipFill>
            <a:blip r:embed="rId4"/>
            <a:srcRect l="22238" t="13163" r="0" b="0"/>
            <a:stretch/>
          </p:blipFill>
          <p:spPr>
            <a:xfrm>
              <a:off x="5151240" y="2128320"/>
              <a:ext cx="876600" cy="900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48" name="Group 10"/>
          <p:cNvGrpSpPr/>
          <p:nvPr/>
        </p:nvGrpSpPr>
        <p:grpSpPr>
          <a:xfrm>
            <a:off x="2550960" y="1407960"/>
            <a:ext cx="1619280" cy="1625760"/>
            <a:chOff x="2550960" y="1407960"/>
            <a:chExt cx="1619280" cy="1625760"/>
          </a:xfrm>
        </p:grpSpPr>
        <p:pic>
          <p:nvPicPr>
            <p:cNvPr id="49" name="Picture 11" descr=""/>
            <p:cNvPicPr/>
            <p:nvPr/>
          </p:nvPicPr>
          <p:blipFill>
            <a:blip r:embed="rId5"/>
            <a:stretch/>
          </p:blipFill>
          <p:spPr>
            <a:xfrm>
              <a:off x="2550960" y="1407960"/>
              <a:ext cx="1619280" cy="1621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0" name="Picture 12" descr=""/>
            <p:cNvPicPr/>
            <p:nvPr/>
          </p:nvPicPr>
          <p:blipFill>
            <a:blip r:embed="rId6"/>
            <a:srcRect l="0" t="0" r="11843" b="5910"/>
            <a:stretch/>
          </p:blipFill>
          <p:spPr>
            <a:xfrm>
              <a:off x="3270600" y="2133000"/>
              <a:ext cx="899640" cy="900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51" name="TextBox 13"/>
          <p:cNvSpPr/>
          <p:nvPr/>
        </p:nvSpPr>
        <p:spPr>
          <a:xfrm>
            <a:off x="2526120" y="1046160"/>
            <a:ext cx="167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NF8 nucleus low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oup 14"/>
          <p:cNvGrpSpPr/>
          <p:nvPr/>
        </p:nvGrpSpPr>
        <p:grpSpPr>
          <a:xfrm>
            <a:off x="1822320" y="2703600"/>
            <a:ext cx="511560" cy="246240"/>
            <a:chOff x="1822320" y="2703600"/>
            <a:chExt cx="511560" cy="246240"/>
          </a:xfrm>
        </p:grpSpPr>
        <p:sp>
          <p:nvSpPr>
            <p:cNvPr id="53" name="Straight Connector 15"/>
            <p:cNvSpPr/>
            <p:nvPr/>
          </p:nvSpPr>
          <p:spPr>
            <a:xfrm>
              <a:off x="1919880" y="2932200"/>
              <a:ext cx="273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6"/>
            <p:cNvSpPr/>
            <p:nvPr/>
          </p:nvSpPr>
          <p:spPr>
            <a:xfrm>
              <a:off x="1822320" y="270360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μ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5" name="Group 17"/>
          <p:cNvGrpSpPr/>
          <p:nvPr/>
        </p:nvGrpSpPr>
        <p:grpSpPr>
          <a:xfrm>
            <a:off x="3616920" y="2703600"/>
            <a:ext cx="511560" cy="246240"/>
            <a:chOff x="3616920" y="2703600"/>
            <a:chExt cx="511560" cy="246240"/>
          </a:xfrm>
        </p:grpSpPr>
        <p:sp>
          <p:nvSpPr>
            <p:cNvPr id="56" name="Straight Connector 18"/>
            <p:cNvSpPr/>
            <p:nvPr/>
          </p:nvSpPr>
          <p:spPr>
            <a:xfrm>
              <a:off x="3714120" y="29322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9"/>
            <p:cNvSpPr/>
            <p:nvPr/>
          </p:nvSpPr>
          <p:spPr>
            <a:xfrm>
              <a:off x="3616920" y="270360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μ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8" name="Group 20"/>
          <p:cNvGrpSpPr/>
          <p:nvPr/>
        </p:nvGrpSpPr>
        <p:grpSpPr>
          <a:xfrm>
            <a:off x="5489280" y="2703600"/>
            <a:ext cx="511560" cy="246240"/>
            <a:chOff x="5489280" y="2703600"/>
            <a:chExt cx="511560" cy="246240"/>
          </a:xfrm>
        </p:grpSpPr>
        <p:sp>
          <p:nvSpPr>
            <p:cNvPr id="59" name="Straight Connector 21"/>
            <p:cNvSpPr/>
            <p:nvPr/>
          </p:nvSpPr>
          <p:spPr>
            <a:xfrm>
              <a:off x="5586840" y="2932200"/>
              <a:ext cx="273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2"/>
            <p:cNvSpPr/>
            <p:nvPr/>
          </p:nvSpPr>
          <p:spPr>
            <a:xfrm>
              <a:off x="5489280" y="270360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μ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" name="TextBox 23"/>
          <p:cNvSpPr/>
          <p:nvPr/>
        </p:nvSpPr>
        <p:spPr>
          <a:xfrm>
            <a:off x="4606560" y="3487680"/>
            <a:ext cx="123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OXM1 high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628560" y="3487680"/>
            <a:ext cx="187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NF168 nucleus low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601360" y="3487680"/>
            <a:ext cx="162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NF8 nucleus low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26"/>
          <p:cNvGrpSpPr/>
          <p:nvPr/>
        </p:nvGrpSpPr>
        <p:grpSpPr>
          <a:xfrm>
            <a:off x="4389480" y="3808440"/>
            <a:ext cx="1620720" cy="1627200"/>
            <a:chOff x="4389480" y="3808440"/>
            <a:chExt cx="1620720" cy="1627200"/>
          </a:xfrm>
        </p:grpSpPr>
        <p:pic>
          <p:nvPicPr>
            <p:cNvPr id="65" name="Picture 2" descr="I:\phD\TMA\RNF168\images\8a d6\FOXM1 high modified.tif"/>
            <p:cNvPicPr/>
            <p:nvPr/>
          </p:nvPicPr>
          <p:blipFill>
            <a:blip r:embed="rId7"/>
            <a:srcRect l="4665" t="0" r="0" b="0"/>
            <a:stretch/>
          </p:blipFill>
          <p:spPr>
            <a:xfrm>
              <a:off x="4389480" y="3808440"/>
              <a:ext cx="1620720" cy="162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6" name="Picture 3" descr="I:\phD\TMA\RNF168\images\8a d6\FOXM1 high amp modified.tif"/>
            <p:cNvPicPr/>
            <p:nvPr/>
          </p:nvPicPr>
          <p:blipFill>
            <a:blip r:embed="rId8"/>
            <a:srcRect l="12778" t="0" r="0" b="10742"/>
            <a:stretch/>
          </p:blipFill>
          <p:spPr>
            <a:xfrm>
              <a:off x="5112000" y="4535640"/>
              <a:ext cx="8982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grpSp>
          <p:nvGrpSpPr>
            <p:cNvPr id="67" name="Group 29"/>
            <p:cNvGrpSpPr/>
            <p:nvPr/>
          </p:nvGrpSpPr>
          <p:grpSpPr>
            <a:xfrm>
              <a:off x="5480280" y="5104080"/>
              <a:ext cx="511560" cy="246240"/>
              <a:chOff x="5480280" y="5104080"/>
              <a:chExt cx="511560" cy="246240"/>
            </a:xfrm>
          </p:grpSpPr>
          <p:sp>
            <p:nvSpPr>
              <p:cNvPr id="68" name="Straight Connector 30"/>
              <p:cNvSpPr/>
              <p:nvPr/>
            </p:nvSpPr>
            <p:spPr>
              <a:xfrm>
                <a:off x="5577840" y="5333040"/>
                <a:ext cx="273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31"/>
              <p:cNvSpPr/>
              <p:nvPr/>
            </p:nvSpPr>
            <p:spPr>
              <a:xfrm>
                <a:off x="5480280" y="510408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μ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70" name="Group 32"/>
          <p:cNvGrpSpPr/>
          <p:nvPr/>
        </p:nvGrpSpPr>
        <p:grpSpPr>
          <a:xfrm>
            <a:off x="2567160" y="3805200"/>
            <a:ext cx="1626840" cy="1630440"/>
            <a:chOff x="2567160" y="3805200"/>
            <a:chExt cx="1626840" cy="1630440"/>
          </a:xfrm>
        </p:grpSpPr>
        <p:pic>
          <p:nvPicPr>
            <p:cNvPr id="71" name="Picture 33" descr=""/>
            <p:cNvPicPr/>
            <p:nvPr/>
          </p:nvPicPr>
          <p:blipFill>
            <a:blip r:embed="rId9"/>
            <a:stretch/>
          </p:blipFill>
          <p:spPr>
            <a:xfrm>
              <a:off x="2567160" y="3805200"/>
              <a:ext cx="1620360" cy="161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2" name="Picture 34" descr=""/>
            <p:cNvPicPr/>
            <p:nvPr/>
          </p:nvPicPr>
          <p:blipFill>
            <a:blip r:embed="rId10"/>
            <a:srcRect l="0" t="0" r="40066" b="43193"/>
            <a:stretch/>
          </p:blipFill>
          <p:spPr>
            <a:xfrm>
              <a:off x="3305520" y="4536000"/>
              <a:ext cx="888480" cy="89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grpSp>
          <p:nvGrpSpPr>
            <p:cNvPr id="73" name="Group 35"/>
            <p:cNvGrpSpPr/>
            <p:nvPr/>
          </p:nvGrpSpPr>
          <p:grpSpPr>
            <a:xfrm>
              <a:off x="3649680" y="5092920"/>
              <a:ext cx="511560" cy="246240"/>
              <a:chOff x="3649680" y="5092920"/>
              <a:chExt cx="511560" cy="246240"/>
            </a:xfrm>
          </p:grpSpPr>
          <p:sp>
            <p:nvSpPr>
              <p:cNvPr id="74" name="Straight Connector 36"/>
              <p:cNvSpPr/>
              <p:nvPr/>
            </p:nvSpPr>
            <p:spPr>
              <a:xfrm>
                <a:off x="3747240" y="5321520"/>
                <a:ext cx="273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TextBox 37"/>
              <p:cNvSpPr/>
              <p:nvPr/>
            </p:nvSpPr>
            <p:spPr>
              <a:xfrm>
                <a:off x="3649680" y="509292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μ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76" name="Group 38"/>
          <p:cNvGrpSpPr/>
          <p:nvPr/>
        </p:nvGrpSpPr>
        <p:grpSpPr>
          <a:xfrm>
            <a:off x="743040" y="3816360"/>
            <a:ext cx="1627200" cy="1619280"/>
            <a:chOff x="743040" y="3816360"/>
            <a:chExt cx="1627200" cy="1619280"/>
          </a:xfrm>
        </p:grpSpPr>
        <p:pic>
          <p:nvPicPr>
            <p:cNvPr id="77" name="Picture 39" descr="I:\phD\TMA\RNF168\images\8a d6\RNF168 low nucl modified.tif"/>
            <p:cNvPicPr/>
            <p:nvPr/>
          </p:nvPicPr>
          <p:blipFill>
            <a:blip r:embed="rId11"/>
            <a:stretch/>
          </p:blipFill>
          <p:spPr>
            <a:xfrm>
              <a:off x="743040" y="3816360"/>
              <a:ext cx="1618560" cy="1619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8" name="Picture 40" descr="I:\phD\TMA\RNF168\images\8a d6\RNF168 low nucl amp_modified.tif"/>
            <p:cNvPicPr/>
            <p:nvPr/>
          </p:nvPicPr>
          <p:blipFill>
            <a:blip r:embed="rId12"/>
            <a:srcRect l="9035" t="4616" r="3645" b="6744"/>
            <a:stretch/>
          </p:blipFill>
          <p:spPr>
            <a:xfrm>
              <a:off x="1452600" y="4533840"/>
              <a:ext cx="901080" cy="89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grpSp>
          <p:nvGrpSpPr>
            <p:cNvPr id="79" name="Group 41"/>
            <p:cNvGrpSpPr/>
            <p:nvPr/>
          </p:nvGrpSpPr>
          <p:grpSpPr>
            <a:xfrm>
              <a:off x="1858680" y="5118840"/>
              <a:ext cx="511560" cy="246240"/>
              <a:chOff x="1858680" y="5118840"/>
              <a:chExt cx="511560" cy="246240"/>
            </a:xfrm>
          </p:grpSpPr>
          <p:sp>
            <p:nvSpPr>
              <p:cNvPr id="80" name="Straight Connector 42"/>
              <p:cNvSpPr/>
              <p:nvPr/>
            </p:nvSpPr>
            <p:spPr>
              <a:xfrm>
                <a:off x="1956240" y="5347440"/>
                <a:ext cx="273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TextBox 43"/>
              <p:cNvSpPr/>
              <p:nvPr/>
            </p:nvSpPr>
            <p:spPr>
              <a:xfrm>
                <a:off x="1858680" y="511884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μ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aphicFrame>
        <p:nvGraphicFramePr>
          <p:cNvPr id="82" name=""/>
          <p:cNvGraphicFramePr/>
          <p:nvPr/>
        </p:nvGraphicFramePr>
        <p:xfrm>
          <a:off x="917640" y="6340320"/>
          <a:ext cx="4687920" cy="2129040"/>
        </p:xfrm>
        <a:graphic>
          <a:graphicData uri="http://schemas.openxmlformats.org/drawingml/2006/table">
            <a:tbl>
              <a:tblPr/>
              <a:tblGrid>
                <a:gridCol w="890640"/>
                <a:gridCol w="977760"/>
                <a:gridCol w="1303200"/>
                <a:gridCol w="1516320"/>
              </a:tblGrid>
              <a:tr h="20016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 Bold"/>
                        </a:rPr>
                        <a:t>Corre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5160"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sk-SK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NF8_nucleus_avg_cutoff_2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M1_total_cutoff_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104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NF8_nucleus_avg_cutoff_2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99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sk-SK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844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M1_total_cutoff_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0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sk-SK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is-I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cs-C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3" name="TextBox 45"/>
          <p:cNvSpPr/>
          <p:nvPr/>
        </p:nvSpPr>
        <p:spPr>
          <a:xfrm>
            <a:off x="5224680" y="9610560"/>
            <a:ext cx="170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sayamas 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8T23:06:26Z</dcterms:created>
  <dc:creator>Eric Lam</dc:creator>
  <dc:description/>
  <dc:language>en-US</dc:language>
  <cp:lastModifiedBy>Microsoft Office User</cp:lastModifiedBy>
  <cp:lastPrinted>2015-09-18T11:48:40Z</cp:lastPrinted>
  <dcterms:modified xsi:type="dcterms:W3CDTF">2016-06-20T11:12:16Z</dcterms:modified>
  <cp:revision>1687</cp:revision>
  <dc:subject/>
  <dc:title>PowerPoint Presentation</dc:title>
</cp:coreProperties>
</file>